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jpe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0" name="组合 9"/>
          <p:cNvGrpSpPr/>
          <p:nvPr/>
        </p:nvGrpSpPr>
        <p:grpSpPr>
          <a:xfrm>
            <a:off x="5943600" y="527050"/>
            <a:ext cx="5299710" cy="5400040"/>
            <a:chOff x="5209" y="1018"/>
            <a:chExt cx="8346" cy="8504"/>
          </a:xfrm>
        </p:grpSpPr>
        <p:pic>
          <p:nvPicPr>
            <p:cNvPr id="2" name="图片 1" descr="1-"/>
            <p:cNvPicPr>
              <a:picLocks noChangeAspect="1"/>
            </p:cNvPicPr>
            <p:nvPr/>
          </p:nvPicPr>
          <p:blipFill>
            <a:blip r:embed="rId1"/>
            <a:srcRect l="23018" t="1549" r="24512" b="27174"/>
            <a:stretch>
              <a:fillRect/>
            </a:stretch>
          </p:blipFill>
          <p:spPr>
            <a:xfrm>
              <a:off x="5209" y="1018"/>
              <a:ext cx="8347" cy="8504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 rot="19020000">
              <a:off x="7413" y="3382"/>
              <a:ext cx="290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positive control</a:t>
              </a:r>
              <a:endParaRPr lang="en-US" altLang="zh-CN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4" name="文本框 3"/>
            <p:cNvSpPr txBox="1"/>
            <p:nvPr/>
          </p:nvSpPr>
          <p:spPr>
            <a:xfrm rot="19020000">
              <a:off x="8479" y="3902"/>
              <a:ext cx="138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HIBEC</a:t>
              </a:r>
              <a:endParaRPr lang="en-US" altLang="zh-CN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 rot="19020000">
              <a:off x="9171" y="3805"/>
              <a:ext cx="16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HUCCT1</a:t>
              </a:r>
              <a:endParaRPr lang="en-US" altLang="zh-CN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 rot="19020000">
              <a:off x="9998" y="3806"/>
              <a:ext cx="167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9810</a:t>
              </a:r>
              <a:endParaRPr lang="en-US" altLang="zh-CN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 rot="19020000">
              <a:off x="10915" y="3967"/>
              <a:ext cx="110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solidFill>
                    <a:schemeClr val="accent3">
                      <a:lumMod val="60000"/>
                      <a:lumOff val="40000"/>
                    </a:schemeClr>
                  </a:solidFill>
                </a:rPr>
                <a:t>SB-1</a:t>
              </a:r>
              <a:endParaRPr lang="en-US" altLang="zh-CN">
                <a:solidFill>
                  <a:schemeClr val="accent3">
                    <a:lumMod val="60000"/>
                    <a:lumOff val="40000"/>
                  </a:schemeClr>
                </a:solidFill>
              </a:endParaRPr>
            </a:p>
          </p:txBody>
        </p:sp>
      </p:grpSp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rcRect l="30494" r="30972" b="13723"/>
          <a:stretch>
            <a:fillRect/>
          </a:stretch>
        </p:blipFill>
        <p:spPr>
          <a:xfrm>
            <a:off x="1252220" y="1014730"/>
            <a:ext cx="2507615" cy="354901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44830" y="4789487"/>
            <a:ext cx="5080000" cy="829945"/>
          </a:xfrm>
          <a:prstGeom prst="rect">
            <a:avLst/>
          </a:prstGeom>
        </p:spPr>
        <p:txBody>
          <a:bodyPr>
            <a:spAutoFit/>
          </a:bodyPr>
          <a:p>
            <a:r>
              <a:rPr lang="en-US" altLang="zh-CN" sz="1600"/>
              <a:t>PCR products were separated on a 2% agarose gel prepared in 1</a:t>
            </a:r>
            <a:r>
              <a:rPr lang="en-US" altLang="en-US" sz="1600"/>
              <a:t>×</a:t>
            </a:r>
            <a:r>
              <a:rPr lang="en-US" altLang="zh-CN" sz="1600"/>
              <a:t> TAE buffer containing 5 μL GelStain and visualized under UV illumination.</a:t>
            </a:r>
            <a:endParaRPr lang="en-US" altLang="zh-CN" sz="16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WPS 演示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'novo</dc:creator>
  <cp:lastModifiedBy>Initial</cp:lastModifiedBy>
  <cp:revision>10</cp:revision>
  <dcterms:created xsi:type="dcterms:W3CDTF">2023-08-09T12:44:00Z</dcterms:created>
  <dcterms:modified xsi:type="dcterms:W3CDTF">2026-03-02T11:35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471E394EAB9748A0A339C3B9F94D9C1B_12</vt:lpwstr>
  </property>
</Properties>
</file>